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Desktop\BMC%20cancer%20Revise\PDCD4%20SMARCA%20SRY220140507_RMG2_data(1).xls&#12288;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Desktop\BMC%20cancer%20Revise\PDCD4%20SMARCA%20SRY220140507_RMG2_data(1).xls&#12288;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Desktop\BMC%20cancer%20Revise\PDCD4%20SMARCA%20SRY220140507_RMG2_data(1).xls&#12288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multiLvlStrRef>
              <c:f>'Results (2)'!$A$30:$B$32</c:f>
              <c:multiLvlStrCache>
                <c:ptCount val="3"/>
                <c:lvl>
                  <c:pt idx="0">
                    <c:v>RMG2-Nu</c:v>
                  </c:pt>
                  <c:pt idx="1">
                    <c:v>RMG2-Nega</c:v>
                  </c:pt>
                  <c:pt idx="2">
                    <c:v>RMG2-si</c:v>
                  </c:pt>
                </c:lvl>
                <c:lvl>
                  <c:pt idx="0">
                    <c:v>PDCD4</c:v>
                  </c:pt>
                </c:lvl>
              </c:multiLvlStrCache>
            </c:multiLvlStrRef>
          </c:cat>
          <c:val>
            <c:numRef>
              <c:f>'Results (2)'!$C$30:$C$32</c:f>
              <c:numCache>
                <c:formatCode>General</c:formatCode>
                <c:ptCount val="3"/>
                <c:pt idx="0">
                  <c:v>9.2346246000000001</c:v>
                </c:pt>
                <c:pt idx="1">
                  <c:v>9.1404714779068801</c:v>
                </c:pt>
                <c:pt idx="2">
                  <c:v>15.0148857521893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9326848"/>
        <c:axId val="198403200"/>
      </c:barChart>
      <c:catAx>
        <c:axId val="2993268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98403200"/>
        <c:crosses val="autoZero"/>
        <c:auto val="1"/>
        <c:lblAlgn val="ctr"/>
        <c:lblOffset val="100"/>
        <c:noMultiLvlLbl val="0"/>
      </c:catAx>
      <c:valAx>
        <c:axId val="198403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99326848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multiLvlStrRef>
              <c:f>'Results (2)'!$A$39:$B$41</c:f>
              <c:multiLvlStrCache>
                <c:ptCount val="3"/>
                <c:lvl>
                  <c:pt idx="0">
                    <c:v>RMG2-Nu</c:v>
                  </c:pt>
                  <c:pt idx="1">
                    <c:v>RMG2-Nega</c:v>
                  </c:pt>
                  <c:pt idx="2">
                    <c:v>RMG2-si</c:v>
                  </c:pt>
                </c:lvl>
                <c:lvl>
                  <c:pt idx="0">
                    <c:v>SMARCA4</c:v>
                  </c:pt>
                </c:lvl>
              </c:multiLvlStrCache>
            </c:multiLvlStrRef>
          </c:cat>
          <c:val>
            <c:numRef>
              <c:f>'Results (2)'!$C$39:$C$41</c:f>
              <c:numCache>
                <c:formatCode>General</c:formatCode>
                <c:ptCount val="3"/>
                <c:pt idx="0">
                  <c:v>8.9798005943709498</c:v>
                </c:pt>
                <c:pt idx="1">
                  <c:v>7.8101763885949778</c:v>
                </c:pt>
                <c:pt idx="2">
                  <c:v>13.3834615221281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431488"/>
        <c:axId val="198433024"/>
      </c:barChart>
      <c:catAx>
        <c:axId val="1984314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98433024"/>
        <c:crosses val="autoZero"/>
        <c:auto val="1"/>
        <c:lblAlgn val="ctr"/>
        <c:lblOffset val="100"/>
        <c:noMultiLvlLbl val="0"/>
      </c:catAx>
      <c:valAx>
        <c:axId val="198433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8431488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multiLvlStrRef>
              <c:f>'Results (2)'!$A$48:$B$50</c:f>
              <c:multiLvlStrCache>
                <c:ptCount val="3"/>
                <c:lvl>
                  <c:pt idx="0">
                    <c:v>RMG2-Nu</c:v>
                  </c:pt>
                  <c:pt idx="1">
                    <c:v>RMG2-Nega</c:v>
                  </c:pt>
                  <c:pt idx="2">
                    <c:v>RMG2-si</c:v>
                  </c:pt>
                </c:lvl>
                <c:lvl>
                  <c:pt idx="0">
                    <c:v>SPRY2</c:v>
                  </c:pt>
                </c:lvl>
              </c:multiLvlStrCache>
            </c:multiLvlStrRef>
          </c:cat>
          <c:val>
            <c:numRef>
              <c:f>'Results (2)'!$C$48:$C$50</c:f>
              <c:numCache>
                <c:formatCode>General</c:formatCode>
                <c:ptCount val="3"/>
                <c:pt idx="0">
                  <c:v>1.4265964</c:v>
                </c:pt>
                <c:pt idx="1">
                  <c:v>1.4790519044263628</c:v>
                </c:pt>
                <c:pt idx="2">
                  <c:v>2.269628588714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494080"/>
        <c:axId val="198495616"/>
      </c:barChart>
      <c:catAx>
        <c:axId val="1984940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98495616"/>
        <c:crosses val="autoZero"/>
        <c:auto val="1"/>
        <c:lblAlgn val="ctr"/>
        <c:lblOffset val="100"/>
        <c:noMultiLvlLbl val="0"/>
      </c:catAx>
      <c:valAx>
        <c:axId val="198495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8494080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571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205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637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219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897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59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4347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4978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0294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833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491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B33E8-CA7E-4CB4-BA38-D0706D0742F1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D6742-FF10-4D67-BA37-485C705D3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861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5463169"/>
              </p:ext>
            </p:extLst>
          </p:nvPr>
        </p:nvGraphicFramePr>
        <p:xfrm>
          <a:off x="912196" y="1196752"/>
          <a:ext cx="3553310" cy="2016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0296874"/>
              </p:ext>
            </p:extLst>
          </p:nvPr>
        </p:nvGraphicFramePr>
        <p:xfrm>
          <a:off x="903366" y="3893531"/>
          <a:ext cx="3554596" cy="2016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4091404"/>
              </p:ext>
            </p:extLst>
          </p:nvPr>
        </p:nvGraphicFramePr>
        <p:xfrm>
          <a:off x="5283418" y="1196752"/>
          <a:ext cx="3744416" cy="2016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395536" y="692696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69886" y="3604495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756351" y="69269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0800000">
            <a:off x="226259" y="1340768"/>
            <a:ext cx="677108" cy="173207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PDCD4</a:t>
            </a: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10800000">
            <a:off x="226258" y="4149080"/>
            <a:ext cx="677108" cy="176426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MARCA</a:t>
            </a:r>
            <a:endParaRPr kumimoji="1" lang="en-US" altLang="ja-JP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0800000">
            <a:off x="4579803" y="1340768"/>
            <a:ext cx="677108" cy="173207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PRY2</a:t>
            </a:r>
            <a:endParaRPr kumimoji="1" lang="en-US" altLang="ja-JP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4167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5</Words>
  <Application>Microsoft Office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hiro</dc:creator>
  <cp:lastModifiedBy>yukihiro</cp:lastModifiedBy>
  <cp:revision>3</cp:revision>
  <dcterms:created xsi:type="dcterms:W3CDTF">2014-07-01T14:39:32Z</dcterms:created>
  <dcterms:modified xsi:type="dcterms:W3CDTF">2014-07-03T23:09:45Z</dcterms:modified>
</cp:coreProperties>
</file>